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13"/>
  </p:notesMasterIdLst>
  <p:sldIdLst>
    <p:sldId id="264" r:id="rId5"/>
    <p:sldId id="266" r:id="rId6"/>
    <p:sldId id="268" r:id="rId7"/>
    <p:sldId id="270" r:id="rId8"/>
    <p:sldId id="272" r:id="rId9"/>
    <p:sldId id="274" r:id="rId10"/>
    <p:sldId id="276" r:id="rId11"/>
    <p:sldId id="278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84"/>
    <p:restoredTop sz="95814"/>
  </p:normalViewPr>
  <p:slideViewPr>
    <p:cSldViewPr snapToGrid="0" snapToObjects="1">
      <p:cViewPr varScale="1">
        <p:scale>
          <a:sx n="117" d="100"/>
          <a:sy n="117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7A447D-5DE7-2840-8533-33E8598F2D27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9566B-208B-8C42-BCCA-0EA06FE801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08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5EF0F-B031-0C43-B190-F15A5003FF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BB8CD1-341F-4944-BC73-6738EB2A06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E485F9-57ED-B242-9F1E-1C962E716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A824F6-C2EE-344D-B827-D055CE10F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C533F5-A9F2-AC48-AFFB-734C814CB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53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619DA6-4E9D-2448-A4B1-2D3FEEAE9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80923E-2991-D145-8286-28D2E3BDDA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68AF37-C75F-E04D-AB72-8514CBEFD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6F1082-3221-5846-A9A7-7C5B82E4D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3020E-3E50-0B44-B2F0-33A5425DB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53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9458FF-8078-BC46-A5CF-A89300E3F6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8012FB-DD27-0B49-99CE-805A52008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54F2DB-D89F-6041-A61E-C5E815F2F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F89401-2237-D14A-B1A0-5F300F589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E4F428-D1B5-7848-9882-B9CD0270B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344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8D3C7-2DD4-8B43-B0F2-7FCE651D3E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5F1B21-8925-E943-924F-111ABA31D2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7837FA-5752-7046-BB1D-72FC4B9D7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324B4-CD2F-5140-9F2B-4659B3386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BB1CC7-13D6-6141-8E0E-4F8D558CD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015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4A871-DEED-EA43-824E-37500252D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358017-2F26-894E-B49D-77642274E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CF1710-B18E-EF47-AE99-4927EE0CB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AADA34-0429-3943-B0A3-9521D1F65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D8D29-EADE-6F4C-AEC8-A88EBDD3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4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18FD3F-A773-0B4C-B76E-07ADF3822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C73165-3504-B143-958C-175C30B483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95318F-AFD2-F746-9E1A-DECBCF11B1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673461-3FFC-6C4D-9348-E1BC68B84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51B4CA-D354-BF42-B529-8D3778888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4F4DFD-83AC-614F-A50B-9CE977D9C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384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53CE3-A1F1-5944-A15C-902805F08C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B48566-3C0D-2B4A-A4CE-A43EE741AF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FE5686-9448-9B49-A643-493A40041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694AFA-2973-274F-B682-301A466037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635574-435E-CD4D-A31D-0ED2E6096C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D4BD77-6942-2A4D-BFCE-CE9F8BE4F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1FC9E8-B5F1-FF4E-BEEA-35C001BFB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1B97CE-0424-2B45-94A6-70DE5B7E4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84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7F5DB-A21C-3F41-86D2-8420B7F5BC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85E85E-E30F-7340-9A40-BA11322D7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D9652D-EE00-E34B-A085-D3E2DA01E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D5D242-8C31-6544-B14E-C5C1269C0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11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B03E3E-ACE2-7542-9BC3-F20982860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9683C9-BFB6-684D-BD51-D0E6BC423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C1761C-330A-2442-9E29-6CF7C65E0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072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9C7F0-F30A-8049-B99E-A96F77C0F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BDBE8-7C7F-FE40-9981-17B9C22E4F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196A87-9BB3-C844-9A48-D09B1561BF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F8C72C-C8A8-CA48-9202-AEF6D9841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1BBB43-81E9-0446-A890-13B3145F4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48490F-979F-384B-876E-AEAD5F529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A2797-F3D0-E642-888A-C7896DCAD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F05FF1-52DD-DF49-8C4F-A90AC1FD2A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FAF080-34D4-A242-A02F-02C642F714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36B28A-DD71-1F42-A5F4-372766D8A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BD27C9-4DB4-ED40-81F9-FECCA547A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2BCA9F-B9B9-E34F-AAE6-FB107F797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017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A7A5DF-AFEC-5C4F-A3E3-79E2FF2D7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F279A5-C929-8A40-97B2-56276E260C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D6C13-BAA7-DE47-B1BD-3FCFEE4D98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8DD82-7FEF-0F4B-8EDF-CEF4EF13AA7E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4D98D6-92FF-A841-B8F8-9F80248ADF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0D74E-D24D-6F42-9994-D238121BE0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EE50E-50FA-D342-AB25-1878CFCE4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685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6901077"/>
              </p:ext>
            </p:extLst>
          </p:nvPr>
        </p:nvGraphicFramePr>
        <p:xfrm>
          <a:off x="2511624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3769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76011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2296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10243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79664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18407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23868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4858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45169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7724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861265" y="440201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628793" y="459744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617699" y="526483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861265" y="3819182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641087" y="400525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843377" y="5074021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391855D-50E1-4747-82FD-6CC05EE5A3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273"/>
          <a:stretch/>
        </p:blipFill>
        <p:spPr>
          <a:xfrm>
            <a:off x="4213610" y="2154326"/>
            <a:ext cx="1104900" cy="38723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C6DD083-44F8-4C48-A4CB-0596A91893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625"/>
          <a:stretch/>
        </p:blipFill>
        <p:spPr>
          <a:xfrm>
            <a:off x="5369028" y="2141814"/>
            <a:ext cx="1231900" cy="3904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8D25822-9115-A241-BEF1-F2A47A143C4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273"/>
          <a:stretch/>
        </p:blipFill>
        <p:spPr>
          <a:xfrm>
            <a:off x="3024288" y="2154326"/>
            <a:ext cx="1130300" cy="387233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22542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2695052"/>
              </p:ext>
            </p:extLst>
          </p:nvPr>
        </p:nvGraphicFramePr>
        <p:xfrm>
          <a:off x="2470803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621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515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8255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0005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6572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27134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56747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45169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9560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804117" y="440201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571645" y="459744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560551" y="532199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804117" y="381918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583939" y="400525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786229" y="5123008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2DDF5E68-CCCC-7E4D-B96C-EC21E1CC6D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768" b="5943"/>
          <a:stretch/>
        </p:blipFill>
        <p:spPr>
          <a:xfrm>
            <a:off x="5384549" y="2154327"/>
            <a:ext cx="1143000" cy="3872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3928557-A13A-5D46-B066-36988E66E6F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540" b="1641"/>
          <a:stretch/>
        </p:blipFill>
        <p:spPr>
          <a:xfrm>
            <a:off x="4201720" y="2154327"/>
            <a:ext cx="1130300" cy="3872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B717A44-A9C4-264E-AC27-6FB8268C49B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963" b="7621"/>
          <a:stretch/>
        </p:blipFill>
        <p:spPr>
          <a:xfrm>
            <a:off x="2970194" y="2154327"/>
            <a:ext cx="1181821" cy="387233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261973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718618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1496323"/>
              </p:ext>
            </p:extLst>
          </p:nvPr>
        </p:nvGraphicFramePr>
        <p:xfrm>
          <a:off x="247896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84173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2612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60248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86255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2657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4926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64911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99761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801739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0915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42919" y="4295877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810447" y="449130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799353" y="524034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42919" y="3713047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822741" y="389911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25031" y="5049528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35E30C6-D97D-E147-9692-780AF5931D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40" b="1915"/>
          <a:stretch/>
        </p:blipFill>
        <p:spPr>
          <a:xfrm>
            <a:off x="4188274" y="2141814"/>
            <a:ext cx="1206500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747B7FA-B37C-C242-9E81-63220C09AF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873" b="6805"/>
          <a:stretch/>
        </p:blipFill>
        <p:spPr>
          <a:xfrm>
            <a:off x="5454067" y="2141814"/>
            <a:ext cx="1316102" cy="3904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C3BF339-FE3A-9D45-8B7D-CE64BE4F36D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7652" b="4191"/>
          <a:stretch/>
        </p:blipFill>
        <p:spPr>
          <a:xfrm>
            <a:off x="2942336" y="2141814"/>
            <a:ext cx="1200586" cy="388484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693107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718618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2820212"/>
              </p:ext>
            </p:extLst>
          </p:nvPr>
        </p:nvGraphicFramePr>
        <p:xfrm>
          <a:off x="2503459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80117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83721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9802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67393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34735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548981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25161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9560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4725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933155" y="435302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700683" y="454845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689589" y="533015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933155" y="3770195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712977" y="395626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915267" y="5139332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5940E1C-4A81-8A4D-8BF0-B17313A7679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279" b="4678"/>
          <a:stretch/>
        </p:blipFill>
        <p:spPr>
          <a:xfrm>
            <a:off x="5474414" y="2141814"/>
            <a:ext cx="1201428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9019E26-AE6A-BC40-96CC-7698A089A6D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76" b="6048"/>
          <a:stretch/>
        </p:blipFill>
        <p:spPr>
          <a:xfrm>
            <a:off x="4207216" y="2141814"/>
            <a:ext cx="1206007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2AEDCCD-BE43-D747-BEB9-01EF2F0929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006" b="11412"/>
          <a:stretch/>
        </p:blipFill>
        <p:spPr>
          <a:xfrm>
            <a:off x="2927269" y="2141814"/>
            <a:ext cx="1221158" cy="388484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72666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718618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7430746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13895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08214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257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60248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86255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2657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4926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50561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69081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4725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993935" y="4361189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761463" y="455661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750369" y="531382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993935" y="3778359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773757" y="396442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976047" y="5123004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BF2140E-ABB8-374F-8F97-5F56B91E13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689"/>
          <a:stretch/>
        </p:blipFill>
        <p:spPr>
          <a:xfrm>
            <a:off x="4219248" y="2141814"/>
            <a:ext cx="1203530" cy="38958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00820AD-94FB-F747-BABE-C1CB6D7FBE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825" b="6880"/>
          <a:stretch/>
        </p:blipFill>
        <p:spPr>
          <a:xfrm>
            <a:off x="5483267" y="2141814"/>
            <a:ext cx="1255906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22B4A5E-840C-AE4B-89A6-BD5CA716131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287" b="6588"/>
          <a:stretch/>
        </p:blipFill>
        <p:spPr>
          <a:xfrm>
            <a:off x="2798084" y="2141814"/>
            <a:ext cx="1355851" cy="388484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5695339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718618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1859780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70354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43355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7808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90045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18912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5000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4926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75961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93574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18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5995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18427" y="441017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785955" y="460560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774861" y="538729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18427" y="378652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798249" y="397259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00539" y="5196480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AB96EA0-DCAE-454F-9507-0C246A1A9C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573" b="2214"/>
          <a:stretch/>
        </p:blipFill>
        <p:spPr>
          <a:xfrm>
            <a:off x="5510383" y="2141814"/>
            <a:ext cx="1248026" cy="38848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46229B0-CC89-074B-9A66-C202336B08D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48" b="1927"/>
          <a:stretch/>
        </p:blipFill>
        <p:spPr>
          <a:xfrm>
            <a:off x="4219918" y="2141814"/>
            <a:ext cx="1222102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A658FDA-5E48-D349-913D-776D209EF7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857" b="5091"/>
          <a:stretch/>
        </p:blipFill>
        <p:spPr>
          <a:xfrm>
            <a:off x="2919115" y="2141814"/>
            <a:ext cx="1238772" cy="390443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6488686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8653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8546628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45861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67848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71045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4735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403679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84200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2038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60337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219003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95550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56747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84869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850725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18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923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87145" y="437751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854673" y="457294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843579" y="535464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87145" y="3794688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866967" y="398075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69257" y="5163825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73AD92C-F9A1-9F45-9080-F3DCCF93B81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031" b="3811"/>
          <a:stretch/>
        </p:blipFill>
        <p:spPr>
          <a:xfrm>
            <a:off x="4229371" y="2141813"/>
            <a:ext cx="1244600" cy="3904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5A850C1-A2D9-2646-878A-2A4A1B0A89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896" b="9610"/>
          <a:stretch/>
        </p:blipFill>
        <p:spPr>
          <a:xfrm>
            <a:off x="2873800" y="2141813"/>
            <a:ext cx="1285400" cy="3904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511AB4C-70C5-674C-A436-A6844A5A670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9390" b="8002"/>
          <a:stretch/>
        </p:blipFill>
        <p:spPr>
          <a:xfrm>
            <a:off x="5530165" y="2141812"/>
            <a:ext cx="1304317" cy="390443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877382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8653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3064417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610959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6464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75557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92579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2038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60337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219003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07075" y="197614"/>
            <a:ext cx="24255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497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999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707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2173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2127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538387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72169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842561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18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923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62653" y="4434670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830181" y="463009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819087" y="541179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62653" y="385184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842475" y="403790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44765" y="522097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F267714-5434-D14A-A7AF-E8580F7D64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523" b="6355"/>
          <a:stretch/>
        </p:blipFill>
        <p:spPr>
          <a:xfrm>
            <a:off x="5528214" y="2141813"/>
            <a:ext cx="1279519" cy="3904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DE91EC2-8343-4149-AE69-E659FEC573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849" b="2455"/>
          <a:stretch/>
        </p:blipFill>
        <p:spPr>
          <a:xfrm>
            <a:off x="4262950" y="2141813"/>
            <a:ext cx="1186203" cy="3904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C306582-2A21-7642-A336-E5A849D5371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470" b="10927"/>
          <a:stretch/>
        </p:blipFill>
        <p:spPr>
          <a:xfrm>
            <a:off x="2823482" y="2141813"/>
            <a:ext cx="1363887" cy="390444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525326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A76C10E-B785-44EE-B5CB-46308CCB915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89FEA32-DB62-41B3-B8B0-45508E3465F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76A76C2-0913-4431-83E1-BE2F58E41D36}">
  <ds:schemaRefs>
    <ds:schemaRef ds:uri="http://purl.org/dc/terms/"/>
    <ds:schemaRef ds:uri="http://schemas.microsoft.com/office/2006/metadata/properties"/>
    <ds:schemaRef ds:uri="http://purl.org/dc/dcmitype/"/>
    <ds:schemaRef ds:uri="http://schemas.microsoft.com/office/2006/documentManagement/types"/>
    <ds:schemaRef ds:uri="http://schemas.openxmlformats.org/package/2006/metadata/core-properties"/>
    <ds:schemaRef ds:uri="0b01a07b-8d13-4cb5-9d22-64822278069e"/>
    <ds:schemaRef ds:uri="http://purl.org/dc/elements/1.1/"/>
    <ds:schemaRef ds:uri="http://schemas.microsoft.com/office/infopath/2007/PartnerControls"/>
    <ds:schemaRef ds:uri="198a9f0d-948e-4f5a-af70-f6d2f30972cd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384</Words>
  <Application>Microsoft Office PowerPoint</Application>
  <PresentationFormat>Widescreen</PresentationFormat>
  <Paragraphs>30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78</cp:revision>
  <dcterms:created xsi:type="dcterms:W3CDTF">2021-10-04T15:04:57Z</dcterms:created>
  <dcterms:modified xsi:type="dcterms:W3CDTF">2021-10-14T19:12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